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  <p:sldId id="265" r:id="rId4"/>
    <p:sldId id="260" r:id="rId5"/>
    <p:sldId id="259" r:id="rId6"/>
    <p:sldId id="262" r:id="rId7"/>
    <p:sldId id="261" r:id="rId8"/>
    <p:sldId id="264" r:id="rId9"/>
    <p:sldId id="263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3" r:id="rId1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80" d="100"/>
          <a:sy n="80" d="100"/>
        </p:scale>
        <p:origin x="66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microsoft.com/office/2015/10/relationships/revisionInfo" Target="revisionInfo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7DB64-F342-446D-B2F4-0389CA5E31AC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9D393-5E87-4F11-9578-75C9BCDB6E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2509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7DB64-F342-446D-B2F4-0389CA5E31AC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9D393-5E87-4F11-9578-75C9BCDB6E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3374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7DB64-F342-446D-B2F4-0389CA5E31AC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9D393-5E87-4F11-9578-75C9BCDB6E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6163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7DB64-F342-446D-B2F4-0389CA5E31AC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9D393-5E87-4F11-9578-75C9BCDB6E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054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7DB64-F342-446D-B2F4-0389CA5E31AC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9D393-5E87-4F11-9578-75C9BCDB6E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96767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7DB64-F342-446D-B2F4-0389CA5E31AC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9D393-5E87-4F11-9578-75C9BCDB6E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35995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7DB64-F342-446D-B2F4-0389CA5E31AC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9D393-5E87-4F11-9578-75C9BCDB6E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1095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7DB64-F342-446D-B2F4-0389CA5E31AC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9D393-5E87-4F11-9578-75C9BCDB6E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08360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7DB64-F342-446D-B2F4-0389CA5E31AC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9D393-5E87-4F11-9578-75C9BCDB6E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46230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7DB64-F342-446D-B2F4-0389CA5E31AC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9D393-5E87-4F11-9578-75C9BCDB6E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38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7DB64-F342-446D-B2F4-0389CA5E31AC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9D393-5E87-4F11-9578-75C9BCDB6E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07610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17DB64-F342-446D-B2F4-0389CA5E31AC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D9D393-5E87-4F11-9578-75C9BCDB6E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0125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DF93DA-B925-4ECC-9FC1-CF17032912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GB" sz="2600" dirty="0"/>
              <a:t>Linear plots showing the effect of triangle count and resolution on topographic metrics. Prosimians and platyrrhines are plotted separately. Plots are presented in the following order: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41DD4C-4C36-4855-9E32-BA00D19A3549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/>
          <a:lstStyle/>
          <a:p>
            <a:r>
              <a:rPr lang="en-GB" dirty="0"/>
              <a:t>Triangle count</a:t>
            </a:r>
          </a:p>
          <a:p>
            <a:pPr lvl="1"/>
            <a:r>
              <a:rPr lang="en-GB" dirty="0"/>
              <a:t>Smoothed, EEC, prosimian</a:t>
            </a:r>
          </a:p>
          <a:p>
            <a:pPr lvl="1"/>
            <a:r>
              <a:rPr lang="en-GB" dirty="0"/>
              <a:t>Smoothed, EEC, platyrrhine</a:t>
            </a:r>
          </a:p>
          <a:p>
            <a:pPr lvl="1"/>
            <a:r>
              <a:rPr lang="en-GB" dirty="0"/>
              <a:t>Smoothed, BCO, prosimian</a:t>
            </a:r>
          </a:p>
          <a:p>
            <a:pPr lvl="1"/>
            <a:r>
              <a:rPr lang="en-GB" dirty="0"/>
              <a:t>Smoothed, BCO, platyrrhine</a:t>
            </a:r>
          </a:p>
          <a:p>
            <a:pPr lvl="1"/>
            <a:r>
              <a:rPr lang="en-GB" dirty="0"/>
              <a:t>Unsmoothed, EEC, prosimian</a:t>
            </a:r>
          </a:p>
          <a:p>
            <a:pPr lvl="1"/>
            <a:r>
              <a:rPr lang="en-GB" dirty="0"/>
              <a:t>Unsmoothed, EEC, platyrrhine</a:t>
            </a:r>
          </a:p>
          <a:p>
            <a:pPr lvl="1"/>
            <a:r>
              <a:rPr lang="en-GB" dirty="0"/>
              <a:t>Unsmoothed, BCO, prosimian</a:t>
            </a:r>
          </a:p>
          <a:p>
            <a:pPr lvl="1"/>
            <a:r>
              <a:rPr lang="en-GB" dirty="0"/>
              <a:t>Unsmoothed, BCO, platyrrhine</a:t>
            </a:r>
          </a:p>
          <a:p>
            <a:pPr lvl="1"/>
            <a:endParaRPr lang="en-GB" dirty="0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F50A10-116F-4D1F-AB1D-E4638BED69C8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r>
              <a:rPr lang="en-GB" dirty="0"/>
              <a:t>Resolution</a:t>
            </a:r>
          </a:p>
          <a:p>
            <a:pPr lvl="1"/>
            <a:r>
              <a:rPr lang="en-GB" dirty="0"/>
              <a:t>Smoothed, EEC, prosimian</a:t>
            </a:r>
          </a:p>
          <a:p>
            <a:pPr lvl="1"/>
            <a:r>
              <a:rPr lang="en-GB" dirty="0"/>
              <a:t>Smoothed, EEC, platyrrhine</a:t>
            </a:r>
          </a:p>
          <a:p>
            <a:pPr lvl="1"/>
            <a:r>
              <a:rPr lang="en-GB" dirty="0"/>
              <a:t>Smoothed, BCO, prosimian</a:t>
            </a:r>
          </a:p>
          <a:p>
            <a:pPr lvl="1"/>
            <a:r>
              <a:rPr lang="en-GB" dirty="0"/>
              <a:t>Smoothed, BCO, platyrrhine</a:t>
            </a:r>
          </a:p>
          <a:p>
            <a:pPr lvl="1"/>
            <a:r>
              <a:rPr lang="en-GB" dirty="0"/>
              <a:t>Unsmoothed, EEC, prosimian</a:t>
            </a:r>
          </a:p>
          <a:p>
            <a:pPr lvl="1"/>
            <a:r>
              <a:rPr lang="en-GB" dirty="0"/>
              <a:t>Unsmoothed, EEC, platyrrhine</a:t>
            </a:r>
          </a:p>
          <a:p>
            <a:pPr lvl="1"/>
            <a:r>
              <a:rPr lang="en-GB" dirty="0"/>
              <a:t>Unsmoothed, BCO, prosimian</a:t>
            </a:r>
          </a:p>
          <a:p>
            <a:pPr lvl="1"/>
            <a:r>
              <a:rPr lang="en-GB" dirty="0"/>
              <a:t>Unsmoothed, BCO, platyrrhine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3757802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0377A1C-AA49-48B2-A8DA-47DC8BD22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olution, smoothed, EEC, prosimian</a:t>
            </a:r>
          </a:p>
        </p:txBody>
      </p:sp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DCBFB04E-0670-485B-84FA-CBD3F104B81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4358" y="2636838"/>
            <a:ext cx="4189284" cy="6284912"/>
          </a:xfrm>
        </p:spPr>
      </p:pic>
    </p:spTree>
    <p:extLst>
      <p:ext uri="{BB962C8B-B14F-4D97-AF65-F5344CB8AC3E}">
        <p14:creationId xmlns:p14="http://schemas.microsoft.com/office/powerpoint/2010/main" val="27850845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0377A1C-AA49-48B2-A8DA-47DC8BD22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olution, smoothed, EEC, platyrrhine</a:t>
            </a:r>
          </a:p>
        </p:txBody>
      </p:sp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8E2FA36C-01E3-48D5-9B17-DE733275900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4358" y="2636838"/>
            <a:ext cx="4189284" cy="6284912"/>
          </a:xfrm>
        </p:spPr>
      </p:pic>
    </p:spTree>
    <p:extLst>
      <p:ext uri="{BB962C8B-B14F-4D97-AF65-F5344CB8AC3E}">
        <p14:creationId xmlns:p14="http://schemas.microsoft.com/office/powerpoint/2010/main" val="43393376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0377A1C-AA49-48B2-A8DA-47DC8BD22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olution, smoothed, BCO, prosimian</a:t>
            </a:r>
          </a:p>
        </p:txBody>
      </p:sp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E5489DF1-38DD-49B4-81DD-BAF6312DB45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4358" y="2636838"/>
            <a:ext cx="4189284" cy="6284912"/>
          </a:xfrm>
        </p:spPr>
      </p:pic>
    </p:spTree>
    <p:extLst>
      <p:ext uri="{BB962C8B-B14F-4D97-AF65-F5344CB8AC3E}">
        <p14:creationId xmlns:p14="http://schemas.microsoft.com/office/powerpoint/2010/main" val="303974372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0377A1C-AA49-48B2-A8DA-47DC8BD22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olution, smoothed, BCO, platyrrhine</a:t>
            </a:r>
          </a:p>
        </p:txBody>
      </p:sp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AC2BFC6C-7C2A-478D-A1CB-940CA141F25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4358" y="2636838"/>
            <a:ext cx="4189284" cy="6284912"/>
          </a:xfrm>
        </p:spPr>
      </p:pic>
    </p:spTree>
    <p:extLst>
      <p:ext uri="{BB962C8B-B14F-4D97-AF65-F5344CB8AC3E}">
        <p14:creationId xmlns:p14="http://schemas.microsoft.com/office/powerpoint/2010/main" val="197210815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0377A1C-AA49-48B2-A8DA-47DC8BD22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olution, unsmoothed, EEC, prosimian</a:t>
            </a:r>
          </a:p>
        </p:txBody>
      </p:sp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A88BE44A-CB29-48B1-B846-BC34447A364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4358" y="2636838"/>
            <a:ext cx="4189284" cy="6284912"/>
          </a:xfrm>
        </p:spPr>
      </p:pic>
    </p:spTree>
    <p:extLst>
      <p:ext uri="{BB962C8B-B14F-4D97-AF65-F5344CB8AC3E}">
        <p14:creationId xmlns:p14="http://schemas.microsoft.com/office/powerpoint/2010/main" val="378092777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0377A1C-AA49-48B2-A8DA-47DC8BD22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olution, unsmoothed, EEC, platyrrhine</a:t>
            </a:r>
          </a:p>
        </p:txBody>
      </p:sp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723B4F66-AEA8-4A44-992F-054522514A1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4358" y="2636838"/>
            <a:ext cx="4189284" cy="6284912"/>
          </a:xfrm>
        </p:spPr>
      </p:pic>
    </p:spTree>
    <p:extLst>
      <p:ext uri="{BB962C8B-B14F-4D97-AF65-F5344CB8AC3E}">
        <p14:creationId xmlns:p14="http://schemas.microsoft.com/office/powerpoint/2010/main" val="212190237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0377A1C-AA49-48B2-A8DA-47DC8BD22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olution, unsmoothed, BCO, prosimian</a:t>
            </a:r>
          </a:p>
        </p:txBody>
      </p:sp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E571334B-67EF-41F2-AD4C-F985D492619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4358" y="2636838"/>
            <a:ext cx="4189284" cy="6284912"/>
          </a:xfrm>
        </p:spPr>
      </p:pic>
    </p:spTree>
    <p:extLst>
      <p:ext uri="{BB962C8B-B14F-4D97-AF65-F5344CB8AC3E}">
        <p14:creationId xmlns:p14="http://schemas.microsoft.com/office/powerpoint/2010/main" val="298018998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0377A1C-AA49-48B2-A8DA-47DC8BD22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olution, unsmoothed, BCO, platyrrhine</a:t>
            </a:r>
          </a:p>
        </p:txBody>
      </p:sp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6E0E3DFC-1D84-4533-9E42-5DFDD803348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4358" y="2636838"/>
            <a:ext cx="4189284" cy="6284912"/>
          </a:xfrm>
        </p:spPr>
      </p:pic>
    </p:spTree>
    <p:extLst>
      <p:ext uri="{BB962C8B-B14F-4D97-AF65-F5344CB8AC3E}">
        <p14:creationId xmlns:p14="http://schemas.microsoft.com/office/powerpoint/2010/main" val="8805163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0377A1C-AA49-48B2-A8DA-47DC8BD22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riangle count, smoothed, EEC, prosimian</a:t>
            </a:r>
          </a:p>
        </p:txBody>
      </p:sp>
      <p:pic>
        <p:nvPicPr>
          <p:cNvPr id="8" name="Content Placeholder 7">
            <a:extLst>
              <a:ext uri="{FF2B5EF4-FFF2-40B4-BE49-F238E27FC236}">
                <a16:creationId xmlns:a16="http://schemas.microsoft.com/office/drawing/2014/main" id="{BC63277A-02D3-4520-B4B4-75E3CAA20B0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4358" y="2636838"/>
            <a:ext cx="4189284" cy="6284912"/>
          </a:xfrm>
        </p:spPr>
      </p:pic>
    </p:spTree>
    <p:extLst>
      <p:ext uri="{BB962C8B-B14F-4D97-AF65-F5344CB8AC3E}">
        <p14:creationId xmlns:p14="http://schemas.microsoft.com/office/powerpoint/2010/main" val="23540813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0377A1C-AA49-48B2-A8DA-47DC8BD22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riangle count, smoothed, EEC, platyrrhine</a:t>
            </a:r>
          </a:p>
        </p:txBody>
      </p:sp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3AB12EBE-6EEC-4C73-8A1B-19C5B607B66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4358" y="2636838"/>
            <a:ext cx="4189284" cy="6284912"/>
          </a:xfrm>
        </p:spPr>
      </p:pic>
    </p:spTree>
    <p:extLst>
      <p:ext uri="{BB962C8B-B14F-4D97-AF65-F5344CB8AC3E}">
        <p14:creationId xmlns:p14="http://schemas.microsoft.com/office/powerpoint/2010/main" val="8292502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0377A1C-AA49-48B2-A8DA-47DC8BD22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riangle count, smoothed, BCO, prosimian</a:t>
            </a:r>
          </a:p>
        </p:txBody>
      </p:sp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F201FB63-FCCD-417A-B580-43F66B43BAA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4358" y="2636838"/>
            <a:ext cx="4189284" cy="6284912"/>
          </a:xfrm>
        </p:spPr>
      </p:pic>
    </p:spTree>
    <p:extLst>
      <p:ext uri="{BB962C8B-B14F-4D97-AF65-F5344CB8AC3E}">
        <p14:creationId xmlns:p14="http://schemas.microsoft.com/office/powerpoint/2010/main" val="28705706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0377A1C-AA49-48B2-A8DA-47DC8BD22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riangle count, smoothed, BCO, platyrrhine</a:t>
            </a:r>
          </a:p>
        </p:txBody>
      </p:sp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6A5A07BC-DC05-4C22-A413-86944324A85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4358" y="2636838"/>
            <a:ext cx="4189284" cy="6284912"/>
          </a:xfrm>
        </p:spPr>
      </p:pic>
    </p:spTree>
    <p:extLst>
      <p:ext uri="{BB962C8B-B14F-4D97-AF65-F5344CB8AC3E}">
        <p14:creationId xmlns:p14="http://schemas.microsoft.com/office/powerpoint/2010/main" val="24960501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0377A1C-AA49-48B2-A8DA-47DC8BD22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riangle count, unsmoothed, EEC, prosimian</a:t>
            </a:r>
          </a:p>
        </p:txBody>
      </p:sp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16E24593-F2BB-44E5-A854-051562ECE75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4358" y="2636838"/>
            <a:ext cx="4189284" cy="6284912"/>
          </a:xfrm>
        </p:spPr>
      </p:pic>
    </p:spTree>
    <p:extLst>
      <p:ext uri="{BB962C8B-B14F-4D97-AF65-F5344CB8AC3E}">
        <p14:creationId xmlns:p14="http://schemas.microsoft.com/office/powerpoint/2010/main" val="2726125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0377A1C-AA49-48B2-A8DA-47DC8BD22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riangle count, unsmoothed, EEC, platyrrhine</a:t>
            </a:r>
          </a:p>
        </p:txBody>
      </p:sp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CC9DFA47-1444-42D0-9F06-F86341988C4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4358" y="2636838"/>
            <a:ext cx="4189284" cy="6284912"/>
          </a:xfrm>
        </p:spPr>
      </p:pic>
    </p:spTree>
    <p:extLst>
      <p:ext uri="{BB962C8B-B14F-4D97-AF65-F5344CB8AC3E}">
        <p14:creationId xmlns:p14="http://schemas.microsoft.com/office/powerpoint/2010/main" val="101629681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0377A1C-AA49-48B2-A8DA-47DC8BD22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riangle count, unsmoothed, BCO, prosimian</a:t>
            </a:r>
          </a:p>
        </p:txBody>
      </p:sp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585455FF-F423-45D7-A1DA-DC266414349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4358" y="2636838"/>
            <a:ext cx="4189284" cy="6284912"/>
          </a:xfrm>
        </p:spPr>
      </p:pic>
    </p:spTree>
    <p:extLst>
      <p:ext uri="{BB962C8B-B14F-4D97-AF65-F5344CB8AC3E}">
        <p14:creationId xmlns:p14="http://schemas.microsoft.com/office/powerpoint/2010/main" val="17186881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0377A1C-AA49-48B2-A8DA-47DC8BD22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Triangle count, unsmoothed, BCO, platyrrhine</a:t>
            </a:r>
          </a:p>
        </p:txBody>
      </p:sp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CF0E7C03-EC6D-45B2-9B93-52593514A56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4358" y="2636838"/>
            <a:ext cx="4189284" cy="6284912"/>
          </a:xfrm>
        </p:spPr>
      </p:pic>
    </p:spTree>
    <p:extLst>
      <p:ext uri="{BB962C8B-B14F-4D97-AF65-F5344CB8AC3E}">
        <p14:creationId xmlns:p14="http://schemas.microsoft.com/office/powerpoint/2010/main" val="11525861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232</Words>
  <Application>Microsoft Office PowerPoint</Application>
  <PresentationFormat>A4 Paper (210x297 mm)</PresentationFormat>
  <Paragraphs>35</Paragraphs>
  <Slides>1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1" baseType="lpstr">
      <vt:lpstr>Arial</vt:lpstr>
      <vt:lpstr>Calibri</vt:lpstr>
      <vt:lpstr>Calibri Light</vt:lpstr>
      <vt:lpstr>Office Theme</vt:lpstr>
      <vt:lpstr>Linear plots showing the effect of triangle count and resolution on topographic metrics. Prosimians and platyrrhines are plotted separately. Plots are presented in the following order:</vt:lpstr>
      <vt:lpstr>Triangle count, smoothed, EEC, prosimian</vt:lpstr>
      <vt:lpstr>Triangle count, smoothed, EEC, platyrrhine</vt:lpstr>
      <vt:lpstr>Triangle count, smoothed, BCO, prosimian</vt:lpstr>
      <vt:lpstr>Triangle count, smoothed, BCO, platyrrhine</vt:lpstr>
      <vt:lpstr>Triangle count, unsmoothed, EEC, prosimian</vt:lpstr>
      <vt:lpstr>Triangle count, unsmoothed, EEC, platyrrhine</vt:lpstr>
      <vt:lpstr>Triangle count, unsmoothed, BCO, prosimian</vt:lpstr>
      <vt:lpstr>Triangle count, unsmoothed, BCO, platyrrhine</vt:lpstr>
      <vt:lpstr>Resolution, smoothed, EEC, prosimian</vt:lpstr>
      <vt:lpstr>Resolution, smoothed, EEC, platyrrhine</vt:lpstr>
      <vt:lpstr>Resolution, smoothed, BCO, prosimian</vt:lpstr>
      <vt:lpstr>Resolution, smoothed, BCO, platyrrhine</vt:lpstr>
      <vt:lpstr>Resolution, unsmoothed, EEC, prosimian</vt:lpstr>
      <vt:lpstr>Resolution, unsmoothed, EEC, platyrrhine</vt:lpstr>
      <vt:lpstr>Resolution, unsmoothed, BCO, prosimian</vt:lpstr>
      <vt:lpstr>Resolution, unsmoothed, BCO, platyrrhin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inear plots showing the effect of triangle count and resolution on topographic metrics. Prosimians and platyrrhines are plotted separately. Plots are presented in the following order:</dc:title>
  <dc:creator>Berthaume, Michael</dc:creator>
  <cp:lastModifiedBy>Berthaume, Michael</cp:lastModifiedBy>
  <cp:revision>4</cp:revision>
  <dcterms:created xsi:type="dcterms:W3CDTF">2018-02-07T09:44:53Z</dcterms:created>
  <dcterms:modified xsi:type="dcterms:W3CDTF">2018-02-07T11:44:29Z</dcterms:modified>
</cp:coreProperties>
</file>